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custDataLst>
    <p:tags r:id="rId4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56"/>
  </p:normalViewPr>
  <p:slideViewPr>
    <p:cSldViewPr snapToGrid="0">
      <p:cViewPr varScale="1">
        <p:scale>
          <a:sx n="107" d="100"/>
          <a:sy n="107" d="100"/>
        </p:scale>
        <p:origin x="97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1FEFEB-AE7F-8B45-8B7B-B1E8DC6E5E31}" type="datetimeFigureOut">
              <a:rPr kumimoji="1" lang="zh-CN" altLang="en-US" smtClean="0"/>
              <a:t>2024/1/8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FC2A97-44DE-2846-ACBC-367E65D0B0B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3FC2A97-44DE-2846-ACBC-367E65D0B0B2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1F5EE-2427-4837-BE25-25878BC6A056}" type="datetimeFigureOut">
              <a:rPr lang="zh-CN" altLang="en-US" smtClean="0"/>
              <a:t>2024/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2CDAA-971A-45C5-8623-995AF76E474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1F5EE-2427-4837-BE25-25878BC6A056}" type="datetimeFigureOut">
              <a:rPr lang="zh-CN" altLang="en-US" smtClean="0"/>
              <a:t>2024/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2CDAA-971A-45C5-8623-995AF76E474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1F5EE-2427-4837-BE25-25878BC6A056}" type="datetimeFigureOut">
              <a:rPr lang="zh-CN" altLang="en-US" smtClean="0"/>
              <a:t>2024/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2CDAA-971A-45C5-8623-995AF76E474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1F5EE-2427-4837-BE25-25878BC6A056}" type="datetimeFigureOut">
              <a:rPr lang="zh-CN" altLang="en-US" smtClean="0"/>
              <a:t>2024/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2CDAA-971A-45C5-8623-995AF76E474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1F5EE-2427-4837-BE25-25878BC6A056}" type="datetimeFigureOut">
              <a:rPr lang="zh-CN" altLang="en-US" smtClean="0"/>
              <a:t>2024/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2CDAA-971A-45C5-8623-995AF76E474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1F5EE-2427-4837-BE25-25878BC6A056}" type="datetimeFigureOut">
              <a:rPr lang="zh-CN" altLang="en-US" smtClean="0"/>
              <a:t>2024/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2CDAA-971A-45C5-8623-995AF76E474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1F5EE-2427-4837-BE25-25878BC6A056}" type="datetimeFigureOut">
              <a:rPr lang="zh-CN" altLang="en-US" smtClean="0"/>
              <a:t>2024/1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2CDAA-971A-45C5-8623-995AF76E474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1F5EE-2427-4837-BE25-25878BC6A056}" type="datetimeFigureOut">
              <a:rPr lang="zh-CN" altLang="en-US" smtClean="0"/>
              <a:t>2024/1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2CDAA-971A-45C5-8623-995AF76E474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1F5EE-2427-4837-BE25-25878BC6A056}" type="datetimeFigureOut">
              <a:rPr lang="zh-CN" altLang="en-US" smtClean="0"/>
              <a:t>2024/1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2CDAA-971A-45C5-8623-995AF76E474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1F5EE-2427-4837-BE25-25878BC6A056}" type="datetimeFigureOut">
              <a:rPr lang="zh-CN" altLang="en-US" smtClean="0"/>
              <a:t>2024/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2CDAA-971A-45C5-8623-995AF76E474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1F5EE-2427-4837-BE25-25878BC6A056}" type="datetimeFigureOut">
              <a:rPr lang="zh-CN" altLang="en-US" smtClean="0"/>
              <a:t>2024/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2CDAA-971A-45C5-8623-995AF76E474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91F5EE-2427-4837-BE25-25878BC6A056}" type="datetimeFigureOut">
              <a:rPr lang="zh-CN" altLang="en-US" smtClean="0"/>
              <a:t>2024/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A2CDAA-971A-45C5-8623-995AF76E474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表格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1042493"/>
              </p:ext>
            </p:extLst>
          </p:nvPr>
        </p:nvGraphicFramePr>
        <p:xfrm>
          <a:off x="265522" y="728189"/>
          <a:ext cx="11660956" cy="547876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1899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4977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9478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95135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75337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79266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75094">
                <a:tc>
                  <a:txBody>
                    <a:bodyPr/>
                    <a:lstStyle/>
                    <a:p>
                      <a:endParaRPr lang="zh-CN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CD</a:t>
                      </a:r>
                      <a:r>
                        <a:rPr lang="zh-CN" altLang="en-US" sz="12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n=5)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SGS</a:t>
                      </a:r>
                      <a:r>
                        <a:rPr lang="zh-CN" altLang="en-US" sz="12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n=5)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gAN</a:t>
                      </a:r>
                      <a:r>
                        <a:rPr lang="zh-CN" altLang="en-US" sz="12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n=5)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SPN</a:t>
                      </a:r>
                      <a:r>
                        <a:rPr lang="zh-CN" altLang="en-US" sz="12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n=5)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N</a:t>
                      </a:r>
                      <a:r>
                        <a:rPr lang="zh-CN" altLang="en-US" sz="12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n=5)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9122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Sex</a:t>
                      </a:r>
                      <a:r>
                        <a:rPr lang="zh-CN" alt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M/F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/1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/1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0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4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6328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ge at biopsy</a:t>
                      </a:r>
                      <a:r>
                        <a:rPr lang="zh-CN" alt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years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±2.24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±2.74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.20±2.59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8±1.64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.40±2.30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4008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erum creatinine concentration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reference range:</a:t>
                      </a:r>
                      <a:r>
                        <a:rPr lang="zh-CN" alt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7-97μmol/l)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1.12±9.80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3.06±34.89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2.70±15.71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1.27±11.24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3.14±41.67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7104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lood urea nitrogen</a:t>
                      </a:r>
                      <a:r>
                        <a:rPr lang="zh-CN" alt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reference range:</a:t>
                      </a:r>
                      <a:r>
                        <a:rPr lang="zh-CN" alt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78-7.14mmol/l)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96±1.14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.66±3.1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.28±1.61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.45±1.72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.83±4.74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6536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ystatin C</a:t>
                      </a:r>
                      <a:r>
                        <a:rPr lang="zh-CN" alt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reference range:</a:t>
                      </a:r>
                      <a:r>
                        <a:rPr lang="zh-CN" alt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59-1.03mg/l)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83±0.31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62±0.8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63±0.36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74±0.39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07±0.91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55806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erum albumin concentration</a:t>
                      </a:r>
                      <a:r>
                        <a:rPr lang="zh-CN" alt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reference range:</a:t>
                      </a:r>
                      <a:r>
                        <a:rPr lang="zh-CN" alt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0-55g/l)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2.36±1.86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.60±2.6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3.29±9.38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9.65±2.18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1.14±8.40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62213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erum cholesterol</a:t>
                      </a:r>
                      <a:r>
                        <a:rPr lang="zh-CN" alt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reference range:</a:t>
                      </a:r>
                      <a:r>
                        <a:rPr lang="zh-CN" alt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-4.1mmol/l)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.84±2.5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.97±2.2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06±2.31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14±1.59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.24±1.45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60089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oteinuria</a:t>
                      </a:r>
                      <a:r>
                        <a:rPr lang="zh-CN" alt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reference range:</a:t>
                      </a:r>
                      <a:r>
                        <a:rPr lang="zh-CN" alt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＜</a:t>
                      </a: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5g/24h)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84±1.25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.82±2.55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20±1.58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88±1.20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64±2.37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60089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zh-CN" alt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FR</a:t>
                      </a:r>
                      <a:r>
                        <a:rPr lang="zh-CN" alt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 </a:t>
                      </a:r>
                      <a:r>
                        <a:rPr lang="en-US" altLang="zh-C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(reference range</a:t>
                      </a:r>
                      <a:r>
                        <a:rPr lang="en-US" altLang="zh-CN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:</a:t>
                      </a:r>
                      <a:r>
                        <a:rPr lang="zh-CN" alt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endParaRPr lang="en-US" altLang="zh-CN" sz="12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endParaRPr>
                    </a:p>
                    <a:p>
                      <a:pPr algn="ctr">
                        <a:buNone/>
                      </a:pPr>
                      <a:r>
                        <a:rPr lang="en-US" altLang="zh-C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＞90ml/min/1.73m2)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zh-CN" alt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97±9.92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zh-CN" alt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49±8.97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00</a:t>
                      </a:r>
                      <a:r>
                        <a:rPr lang="zh-CN" alt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±8.</a:t>
                      </a:r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13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70.19</a:t>
                      </a:r>
                      <a:r>
                        <a:rPr lang="zh-CN" alt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±</a:t>
                      </a:r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11.23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zh-CN" alt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5</a:t>
                      </a:r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9</a:t>
                      </a:r>
                      <a:r>
                        <a:rPr lang="zh-CN" alt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.</a:t>
                      </a:r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37</a:t>
                      </a:r>
                      <a:r>
                        <a:rPr lang="zh-CN" alt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±</a:t>
                      </a:r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14.72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15" name="文本框 14"/>
          <p:cNvSpPr txBox="1"/>
          <p:nvPr/>
        </p:nvSpPr>
        <p:spPr>
          <a:xfrm>
            <a:off x="2451420" y="366696"/>
            <a:ext cx="728915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plemental Table. </a:t>
            </a:r>
            <a:r>
              <a:rPr lang="en-US" altLang="zh-CN" sz="12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</a:t>
            </a:r>
            <a:r>
              <a:rPr lang="en-US" altLang="zh-CN" sz="1200" b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e clinical characteristics in children with Glomerular Diseases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MTdiYWJkYzk1YTZiYWY1NWIzNzcxMTE3MTc5ZTIwNTk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87</Words>
  <Application>Microsoft Macintosh PowerPoint</Application>
  <PresentationFormat>宽屏</PresentationFormat>
  <Paragraphs>63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251451346@qq.com</dc:creator>
  <cp:lastModifiedBy>Jainve</cp:lastModifiedBy>
  <cp:revision>59</cp:revision>
  <dcterms:created xsi:type="dcterms:W3CDTF">2023-02-23T11:38:00Z</dcterms:created>
  <dcterms:modified xsi:type="dcterms:W3CDTF">2024-01-08T06:21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8546E756DC8405F815910B2C712C10D_12</vt:lpwstr>
  </property>
  <property fmtid="{D5CDD505-2E9C-101B-9397-08002B2CF9AE}" pid="3" name="KSOProductBuildVer">
    <vt:lpwstr>2052-12.1.0.15990</vt:lpwstr>
  </property>
</Properties>
</file>